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17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27605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89056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83570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60082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55586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47128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71578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923562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40112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25021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04362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4ECAE-0C66-4467-AE87-FDBC53C523A6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551F8-2D73-48F5-99A0-681818EFF752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30915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table"/>
          <p:cNvPicPr/>
          <p:nvPr/>
        </p:nvPicPr>
        <p:blipFill>
          <a:blip r:embed="rId2"/>
          <a:stretch>
            <a:fillRect/>
          </a:stretch>
        </p:blipFill>
        <p:spPr>
          <a:xfrm>
            <a:off x="5580112" y="2035324"/>
            <a:ext cx="3203575" cy="2343785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270509" y="1467598"/>
            <a:ext cx="4968242" cy="4966335"/>
            <a:chOff x="0" y="0"/>
            <a:chExt cx="4968552" cy="4966832"/>
          </a:xfrm>
        </p:grpSpPr>
        <p:sp>
          <p:nvSpPr>
            <p:cNvPr id="6" name="Text Box 2"/>
            <p:cNvSpPr txBox="1">
              <a:spLocks noChangeArrowheads="1"/>
            </p:cNvSpPr>
            <p:nvPr/>
          </p:nvSpPr>
          <p:spPr bwMode="auto">
            <a:xfrm>
              <a:off x="1109427" y="1279326"/>
              <a:ext cx="3859125" cy="92093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IE" sz="900">
                  <a:solidFill>
                    <a:srgbClr val="000000"/>
                  </a:solidFill>
                  <a:effectLst/>
                  <a:latin typeface="Cambria"/>
                  <a:ea typeface="Times New Roman"/>
                  <a:cs typeface="Times New Roman"/>
                </a:rPr>
                <a:t>Rhizospheric soil samples (1 plant/plot) extracted from each potato genotype for both control and chemical treatment (09/08/2013, 05-07/08/2014, 05-08/08/2015). </a:t>
              </a:r>
              <a:r>
                <a:rPr lang="en-IE" sz="900">
                  <a:solidFill>
                    <a:srgbClr val="000000"/>
                  </a:solidFill>
                  <a:effectLst/>
                  <a:latin typeface="Cambria"/>
                  <a:ea typeface="Calibri"/>
                </a:rPr>
                <a:t>4 plots (per treatment) randomly sampled from site 1 (giving R1, R2, R3 R4), 3 plots (per treatment randomly sampled from site 2</a:t>
              </a:r>
              <a:r>
                <a:rPr lang="en-IE" sz="900" kern="1200">
                  <a:solidFill>
                    <a:srgbClr val="000000"/>
                  </a:solidFill>
                  <a:effectLst/>
                  <a:latin typeface="Cambria"/>
                  <a:ea typeface="Calibri"/>
                </a:rPr>
                <a:t> (giving R5, R6, R7)</a:t>
              </a:r>
              <a:endParaRPr lang="en-IE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7" name="Text Box 2"/>
            <p:cNvSpPr txBox="1">
              <a:spLocks noChangeArrowheads="1"/>
            </p:cNvSpPr>
            <p:nvPr/>
          </p:nvSpPr>
          <p:spPr bwMode="auto">
            <a:xfrm>
              <a:off x="1109427" y="3738814"/>
              <a:ext cx="2316569" cy="581333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IE" sz="900" kern="1200">
                  <a:solidFill>
                    <a:srgbClr val="000000"/>
                  </a:solidFill>
                  <a:effectLst/>
                  <a:latin typeface="Cambria"/>
                  <a:ea typeface="Calibri"/>
                </a:rPr>
                <a:t>Composite PCR samples made for each of the 6 treatments by combining 35 PCR reactions (5 PCR x 7 replicates)</a:t>
              </a:r>
              <a:endParaRPr lang="en-IE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8" name="Text Box 2"/>
            <p:cNvSpPr txBox="1">
              <a:spLocks noChangeArrowheads="1"/>
            </p:cNvSpPr>
            <p:nvPr/>
          </p:nvSpPr>
          <p:spPr bwMode="auto">
            <a:xfrm>
              <a:off x="1102924" y="4630540"/>
              <a:ext cx="2323072" cy="2286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IE" sz="900" kern="1200">
                  <a:solidFill>
                    <a:srgbClr val="000000"/>
                  </a:solidFill>
                  <a:effectLst/>
                  <a:latin typeface="Cambria"/>
                  <a:ea typeface="Calibri"/>
                </a:rPr>
                <a:t>50 clones Sanger sequenced per composite</a:t>
              </a:r>
              <a:endParaRPr lang="en-IE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9" name="TextBox 1"/>
            <p:cNvSpPr txBox="1"/>
            <p:nvPr/>
          </p:nvSpPr>
          <p:spPr>
            <a:xfrm>
              <a:off x="1125654" y="1388"/>
              <a:ext cx="3842385" cy="1181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IE" sz="900" kern="1200">
                  <a:solidFill>
                    <a:srgbClr val="000000"/>
                  </a:solidFill>
                  <a:effectLst/>
                  <a:latin typeface="Calibri"/>
                  <a:ea typeface="Calibri"/>
                </a:rPr>
                <a:t>Potato genotypes: Desiree, Cisgenic Desiree and Sarpo Mira</a:t>
              </a:r>
              <a:endParaRPr lang="en-IE" sz="1200">
                <a:effectLst/>
                <a:latin typeface="Times New Roman"/>
                <a:ea typeface="Times New Roman"/>
              </a:endParaRP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IE" sz="900" kern="1200">
                  <a:solidFill>
                    <a:srgbClr val="000000"/>
                  </a:solidFill>
                  <a:effectLst/>
                  <a:latin typeface="Calibri"/>
                  <a:ea typeface="Calibri"/>
                </a:rPr>
                <a:t>Disease management: control, chemical disease management (and IPM*)</a:t>
              </a:r>
              <a:endParaRPr lang="en-IE" sz="1200">
                <a:effectLst/>
                <a:latin typeface="Times New Roman"/>
                <a:ea typeface="Times New Roman"/>
              </a:endParaRP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IE" sz="900" kern="1200">
                  <a:solidFill>
                    <a:srgbClr val="000000"/>
                  </a:solidFill>
                  <a:effectLst/>
                  <a:latin typeface="Calibri"/>
                  <a:ea typeface="Calibri"/>
                </a:rPr>
                <a:t>Experiment design: 6 treatments (3 genotypes x 2 treatments) in a replicate randomised block design, duplicated across 2 sites (site 1 and 2)</a:t>
              </a:r>
              <a:endParaRPr lang="en-IE" sz="1200">
                <a:effectLst/>
                <a:latin typeface="Times New Roman"/>
                <a:ea typeface="Times New Roman"/>
              </a:endParaRP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IE" sz="900" kern="1200">
                  <a:solidFill>
                    <a:srgbClr val="000000"/>
                  </a:solidFill>
                  <a:effectLst/>
                  <a:latin typeface="Calibri"/>
                  <a:ea typeface="Calibri"/>
                </a:rPr>
                <a:t>Sowing: 18/06/2013, 30-04/05-06/2014, 29-04/05-06/2015</a:t>
              </a:r>
              <a:endParaRPr lang="en-IE" sz="1200">
                <a:effectLst/>
                <a:latin typeface="Times New Roman"/>
                <a:ea typeface="Times New Roman"/>
              </a:endParaRP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IE" sz="900" kern="1200">
                  <a:solidFill>
                    <a:srgbClr val="000000"/>
                  </a:solidFill>
                  <a:effectLst/>
                  <a:latin typeface="Calibri"/>
                  <a:ea typeface="Calibri"/>
                </a:rPr>
                <a:t>Number of fungicide applications: 11(2013), 10(2014), 11(2015)</a:t>
              </a:r>
              <a:endParaRPr lang="en-IE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0" name="TextBox 2"/>
            <p:cNvSpPr txBox="1"/>
            <p:nvPr/>
          </p:nvSpPr>
          <p:spPr>
            <a:xfrm>
              <a:off x="1102855" y="2367763"/>
              <a:ext cx="2287270" cy="3976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IE" sz="900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R1, R2, R3, R4, R5, R6, R7: for each treatment</a:t>
              </a:r>
              <a:endParaRPr lang="en-IE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1" name="TextBox 57"/>
            <p:cNvSpPr txBox="1"/>
            <p:nvPr/>
          </p:nvSpPr>
          <p:spPr>
            <a:xfrm>
              <a:off x="1109357" y="3005873"/>
              <a:ext cx="2316480" cy="37020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IE" sz="900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5 PCR reactions completed for each replicate (R1 – R7) per treatment (n = 6)</a:t>
              </a:r>
              <a:endParaRPr lang="en-IE" sz="120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12" name="Straight Connector 11"/>
            <p:cNvCxnSpPr/>
            <p:nvPr/>
          </p:nvCxnSpPr>
          <p:spPr>
            <a:xfrm>
              <a:off x="937890" y="0"/>
              <a:ext cx="0" cy="4966832"/>
            </a:xfrm>
            <a:prstGeom prst="line">
              <a:avLst/>
            </a:prstGeom>
            <a:ln w="38100"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 Box 2"/>
            <p:cNvSpPr txBox="1">
              <a:spLocks noChangeArrowheads="1"/>
            </p:cNvSpPr>
            <p:nvPr/>
          </p:nvSpPr>
          <p:spPr bwMode="auto">
            <a:xfrm rot="16200000">
              <a:off x="-442015" y="447675"/>
              <a:ext cx="1238250" cy="3429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prstDash val="sysDot"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IE" sz="1000" kern="1200">
                  <a:solidFill>
                    <a:srgbClr val="000000"/>
                  </a:solidFill>
                  <a:effectLst/>
                  <a:latin typeface="Calibri"/>
                  <a:ea typeface="Calibri"/>
                </a:rPr>
                <a:t>Field study details</a:t>
              </a:r>
              <a:endParaRPr lang="en-IE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4" name="Text Box 2"/>
            <p:cNvSpPr txBox="1">
              <a:spLocks noChangeArrowheads="1"/>
            </p:cNvSpPr>
            <p:nvPr/>
          </p:nvSpPr>
          <p:spPr bwMode="auto">
            <a:xfrm rot="16200000">
              <a:off x="-443390" y="2028812"/>
              <a:ext cx="1238250" cy="3429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prstDash val="sysDot"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IE" sz="1000" kern="1200">
                  <a:solidFill>
                    <a:srgbClr val="000000"/>
                  </a:solidFill>
                  <a:effectLst/>
                  <a:latin typeface="Calibri"/>
                  <a:ea typeface="Calibri"/>
                </a:rPr>
                <a:t>Sampling</a:t>
              </a:r>
              <a:endParaRPr lang="en-IE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5" name="Text Box 2"/>
            <p:cNvSpPr txBox="1">
              <a:spLocks noChangeArrowheads="1"/>
            </p:cNvSpPr>
            <p:nvPr/>
          </p:nvSpPr>
          <p:spPr bwMode="auto">
            <a:xfrm rot="16200000">
              <a:off x="-450734" y="3715758"/>
              <a:ext cx="1238250" cy="33678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prstDash val="sysDot"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IE" sz="1000" kern="1200">
                  <a:solidFill>
                    <a:srgbClr val="000000"/>
                  </a:solidFill>
                  <a:effectLst/>
                  <a:latin typeface="Calibri"/>
                  <a:ea typeface="Calibri"/>
                </a:rPr>
                <a:t>Molecular analysis</a:t>
              </a:r>
              <a:endParaRPr lang="en-IE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6" name="Left Brace 15"/>
            <p:cNvSpPr/>
            <p:nvPr/>
          </p:nvSpPr>
          <p:spPr>
            <a:xfrm>
              <a:off x="486370" y="0"/>
              <a:ext cx="288032" cy="1212874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IE" sz="1100">
                  <a:effectLst/>
                  <a:ea typeface="Times New Roman"/>
                  <a:cs typeface="Times New Roman"/>
                </a:rPr>
                <a:t> </a:t>
              </a:r>
              <a:endParaRPr lang="en-IE" sz="1100">
                <a:effectLst/>
                <a:ea typeface="Calibri"/>
                <a:cs typeface="Times New Roman"/>
              </a:endParaRPr>
            </a:p>
          </p:txBody>
        </p:sp>
        <p:sp>
          <p:nvSpPr>
            <p:cNvPr id="17" name="Left Brace 16"/>
            <p:cNvSpPr/>
            <p:nvPr/>
          </p:nvSpPr>
          <p:spPr>
            <a:xfrm>
              <a:off x="497210" y="1279327"/>
              <a:ext cx="288032" cy="1581157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IE" sz="1100">
                  <a:effectLst/>
                  <a:ea typeface="Times New Roman"/>
                  <a:cs typeface="Times New Roman"/>
                </a:rPr>
                <a:t> </a:t>
              </a:r>
              <a:endParaRPr lang="en-IE" sz="1100">
                <a:effectLst/>
                <a:ea typeface="Calibri"/>
                <a:cs typeface="Times New Roman"/>
              </a:endParaRPr>
            </a:p>
          </p:txBody>
        </p:sp>
        <p:sp>
          <p:nvSpPr>
            <p:cNvPr id="18" name="Left Brace 17"/>
            <p:cNvSpPr/>
            <p:nvPr/>
          </p:nvSpPr>
          <p:spPr>
            <a:xfrm>
              <a:off x="486370" y="3005234"/>
              <a:ext cx="288032" cy="1853905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IE" sz="1100">
                  <a:effectLst/>
                  <a:ea typeface="Times New Roman"/>
                  <a:cs typeface="Times New Roman"/>
                </a:rPr>
                <a:t> </a:t>
              </a:r>
              <a:endParaRPr lang="en-IE" sz="1100">
                <a:effectLst/>
                <a:ea typeface="Calibri"/>
                <a:cs typeface="Times New Roman"/>
              </a:endParaRPr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0213" y="87631"/>
            <a:ext cx="5743575" cy="865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43021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4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eaga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wen Mullins</dc:creator>
  <cp:lastModifiedBy>Ewen Mullins</cp:lastModifiedBy>
  <cp:revision>1</cp:revision>
  <dcterms:created xsi:type="dcterms:W3CDTF">2016-11-17T13:38:57Z</dcterms:created>
  <dcterms:modified xsi:type="dcterms:W3CDTF">2016-11-17T13:40:15Z</dcterms:modified>
</cp:coreProperties>
</file>